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72" autoAdjust="0"/>
    <p:restoredTop sz="94660"/>
  </p:normalViewPr>
  <p:slideViewPr>
    <p:cSldViewPr snapToGrid="0">
      <p:cViewPr>
        <p:scale>
          <a:sx n="50" d="100"/>
          <a:sy n="50" d="100"/>
        </p:scale>
        <p:origin x="-1008" y="-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2.xml"/><Relationship Id="rId3" Type="http://schemas.microsoft.com/office/2011/relationships/chartColorStyle" Target="colors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3.xml"/><Relationship Id="rId3" Type="http://schemas.microsoft.com/office/2011/relationships/chartColorStyle" Target="colors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4.xml"/><Relationship Id="rId3" Type="http://schemas.microsoft.com/office/2011/relationships/chartColorStyle" Target="colors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831-4639-B0EE-F626FB0CCB2D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49,'LMAN_Average, HSV'!$D$49:$K$49)</c:f>
                <c:numCache>
                  <c:formatCode>General</c:formatCode>
                  <c:ptCount val="9"/>
                  <c:pt idx="0">
                    <c:v>0.144234107375152</c:v>
                  </c:pt>
                  <c:pt idx="1">
                    <c:v>0.168502324918022</c:v>
                  </c:pt>
                  <c:pt idx="2">
                    <c:v>0.00393185633336098</c:v>
                  </c:pt>
                  <c:pt idx="3">
                    <c:v>0.0285353421122262</c:v>
                  </c:pt>
                  <c:pt idx="4">
                    <c:v>0.0585407346420255</c:v>
                  </c:pt>
                  <c:pt idx="5">
                    <c:v>0.110494472138344</c:v>
                  </c:pt>
                  <c:pt idx="6">
                    <c:v>0.0741872906160338</c:v>
                  </c:pt>
                  <c:pt idx="7">
                    <c:v>0.0700505724733624</c:v>
                  </c:pt>
                  <c:pt idx="8">
                    <c:v>0.11739700988112</c:v>
                  </c:pt>
                </c:numCache>
              </c:numRef>
            </c:plus>
            <c:minus>
              <c:numRef>
                <c:f>('LMAN_Average, HSV'!$B$49,'LMAN_Average, HSV'!$D$49:$K$49)</c:f>
                <c:numCache>
                  <c:formatCode>General</c:formatCode>
                  <c:ptCount val="9"/>
                  <c:pt idx="0">
                    <c:v>0.144234107375152</c:v>
                  </c:pt>
                  <c:pt idx="1">
                    <c:v>0.168502324918022</c:v>
                  </c:pt>
                  <c:pt idx="2">
                    <c:v>0.00393185633336098</c:v>
                  </c:pt>
                  <c:pt idx="3">
                    <c:v>0.0285353421122262</c:v>
                  </c:pt>
                  <c:pt idx="4">
                    <c:v>0.0585407346420255</c:v>
                  </c:pt>
                  <c:pt idx="5">
                    <c:v>0.110494472138344</c:v>
                  </c:pt>
                  <c:pt idx="6">
                    <c:v>0.0741872906160338</c:v>
                  </c:pt>
                  <c:pt idx="7">
                    <c:v>0.0700505724733624</c:v>
                  </c:pt>
                  <c:pt idx="8">
                    <c:v>0.11739700988112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('LMAN_Average, HSV'!$B$47,'LMAN_Average, HSV'!$D$47:$K$47)</c:f>
              <c:numCache>
                <c:formatCode>General</c:formatCode>
                <c:ptCount val="9"/>
                <c:pt idx="0">
                  <c:v>-0.153328803587785</c:v>
                </c:pt>
                <c:pt idx="1">
                  <c:v>-0.158929050313602</c:v>
                </c:pt>
                <c:pt idx="2">
                  <c:v>-0.0366848624975936</c:v>
                </c:pt>
                <c:pt idx="3">
                  <c:v>-0.0308790192957046</c:v>
                </c:pt>
                <c:pt idx="4">
                  <c:v>-0.0637200114035131</c:v>
                </c:pt>
                <c:pt idx="5">
                  <c:v>-0.0769838233550336</c:v>
                </c:pt>
                <c:pt idx="6">
                  <c:v>-0.105601750259766</c:v>
                </c:pt>
                <c:pt idx="7">
                  <c:v>-0.0695812454679858</c:v>
                </c:pt>
                <c:pt idx="8">
                  <c:v>-0.1501703633222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831-4639-B0EE-F626FB0CCB2D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53,'LMAN_Average, HSV'!$D$53:$K$53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plus>
            <c:minus>
              <c:numRef>
                <c:f>('LMAN_Average, HSV'!$B$53,'LMAN_Average, HSV'!$D$53:$K$53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LMAN_Average, HSV'!$B$51,'LMAN_Average, HSV'!$D$51:$K$51)</c:f>
              <c:numCache>
                <c:formatCode>General</c:formatCode>
                <c:ptCount val="9"/>
                <c:pt idx="0">
                  <c:v>-0.00717018180753137</c:v>
                </c:pt>
                <c:pt idx="1">
                  <c:v>0.0574937540080207</c:v>
                </c:pt>
                <c:pt idx="2">
                  <c:v>0.00740049973922074</c:v>
                </c:pt>
                <c:pt idx="3">
                  <c:v>0.0169369994483522</c:v>
                </c:pt>
                <c:pt idx="4">
                  <c:v>-0.00765234754301151</c:v>
                </c:pt>
                <c:pt idx="5">
                  <c:v>0.0222960600269891</c:v>
                </c:pt>
                <c:pt idx="6">
                  <c:v>-0.0053356289719826</c:v>
                </c:pt>
                <c:pt idx="7">
                  <c:v>-0.00182609799951625</c:v>
                </c:pt>
                <c:pt idx="8">
                  <c:v>0.0386037080556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831-4639-B0EE-F626FB0CCB2D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45,'LMAN_Average, HSV'!$D$45:$K$45)</c:f>
                <c:numCache>
                  <c:formatCode>General</c:formatCode>
                  <c:ptCount val="9"/>
                  <c:pt idx="0">
                    <c:v>0.0883410960235057</c:v>
                  </c:pt>
                  <c:pt idx="1">
                    <c:v>0.00664488018471285</c:v>
                  </c:pt>
                  <c:pt idx="2">
                    <c:v>0.038578239845217</c:v>
                  </c:pt>
                  <c:pt idx="3">
                    <c:v>0.0862696632618682</c:v>
                  </c:pt>
                  <c:pt idx="4">
                    <c:v>0.0465412089836878</c:v>
                  </c:pt>
                  <c:pt idx="5">
                    <c:v>0.0179362668638396</c:v>
                  </c:pt>
                  <c:pt idx="6">
                    <c:v>0.0583348031773123</c:v>
                  </c:pt>
                  <c:pt idx="7">
                    <c:v>0.0242486687391364</c:v>
                  </c:pt>
                  <c:pt idx="8">
                    <c:v>0.0539040153863383</c:v>
                  </c:pt>
                </c:numCache>
              </c:numRef>
            </c:plus>
            <c:minus>
              <c:numRef>
                <c:f>('LMAN_Average, HSV'!$B$45,'LMAN_Average, HSV'!$D$45:$K$45)</c:f>
                <c:numCache>
                  <c:formatCode>General</c:formatCode>
                  <c:ptCount val="9"/>
                  <c:pt idx="0">
                    <c:v>0.0883410960235057</c:v>
                  </c:pt>
                  <c:pt idx="1">
                    <c:v>0.00664488018471285</c:v>
                  </c:pt>
                  <c:pt idx="2">
                    <c:v>0.038578239845217</c:v>
                  </c:pt>
                  <c:pt idx="3">
                    <c:v>0.0862696632618682</c:v>
                  </c:pt>
                  <c:pt idx="4">
                    <c:v>0.0465412089836878</c:v>
                  </c:pt>
                  <c:pt idx="5">
                    <c:v>0.0179362668638396</c:v>
                  </c:pt>
                  <c:pt idx="6">
                    <c:v>0.0583348031773123</c:v>
                  </c:pt>
                  <c:pt idx="7">
                    <c:v>0.0242486687391364</c:v>
                  </c:pt>
                  <c:pt idx="8">
                    <c:v>0.0539040153863383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('LMAN_Average, HSV'!$B$43,'LMAN_Average, HSV'!$D$43:$K$43)</c:f>
              <c:numCache>
                <c:formatCode>General</c:formatCode>
                <c:ptCount val="9"/>
                <c:pt idx="0">
                  <c:v>0.205356429905708</c:v>
                </c:pt>
                <c:pt idx="1">
                  <c:v>0.0576065086126513</c:v>
                </c:pt>
                <c:pt idx="2">
                  <c:v>0.053718139166661</c:v>
                </c:pt>
                <c:pt idx="3">
                  <c:v>0.117624372852125</c:v>
                </c:pt>
                <c:pt idx="4">
                  <c:v>0.0149867754294325</c:v>
                </c:pt>
                <c:pt idx="5">
                  <c:v>0.126604588450603</c:v>
                </c:pt>
                <c:pt idx="6">
                  <c:v>0.0278888374013602</c:v>
                </c:pt>
                <c:pt idx="7">
                  <c:v>0.00532709074164119</c:v>
                </c:pt>
                <c:pt idx="8">
                  <c:v>-0.03121790761516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831-4639-B0EE-F626FB0CCB2D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1831-4639-B0EE-F626FB0CC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98200488"/>
        <c:axId val="-319451736"/>
      </c:barChart>
      <c:catAx>
        <c:axId val="199820048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19451736"/>
        <c:crosses val="autoZero"/>
        <c:auto val="1"/>
        <c:lblAlgn val="ctr"/>
        <c:lblOffset val="100"/>
        <c:noMultiLvlLbl val="0"/>
      </c:catAx>
      <c:valAx>
        <c:axId val="-319451736"/>
        <c:scaling>
          <c:orientation val="minMax"/>
          <c:max val="0.25"/>
          <c:min val="-0.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8200488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Y$49</c:f>
                <c:numCache>
                  <c:formatCode>General</c:formatCode>
                  <c:ptCount val="1"/>
                  <c:pt idx="0">
                    <c:v>0.00126206081032564</c:v>
                  </c:pt>
                </c:numCache>
              </c:numRef>
            </c:plus>
            <c:minus>
              <c:numRef>
                <c:f>'LMAN_Average, HSV'!$Y$49</c:f>
                <c:numCache>
                  <c:formatCode>General</c:formatCode>
                  <c:ptCount val="1"/>
                  <c:pt idx="0">
                    <c:v>0.0012620608103256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HSV'!$Y$47</c:f>
              <c:numCache>
                <c:formatCode>General</c:formatCode>
                <c:ptCount val="1"/>
                <c:pt idx="0">
                  <c:v>0.002107769149812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357-4134-82AD-1BA579A1975E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Y$53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plus>
            <c:minus>
              <c:numRef>
                <c:f>'LMAN_Average, HSV'!$Y$53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HSV'!$Y$51</c:f>
              <c:numCache>
                <c:formatCode>General</c:formatCode>
                <c:ptCount val="1"/>
                <c:pt idx="0">
                  <c:v>0.0001128853422126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357-4134-82AD-1BA579A1975E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Y$45</c:f>
                <c:numCache>
                  <c:formatCode>General</c:formatCode>
                  <c:ptCount val="1"/>
                  <c:pt idx="0">
                    <c:v>0.00732497417145586</c:v>
                  </c:pt>
                </c:numCache>
              </c:numRef>
            </c:plus>
            <c:minus>
              <c:numRef>
                <c:f>'LMAN_Average, HSV'!$Y$45</c:f>
                <c:numCache>
                  <c:formatCode>General</c:formatCode>
                  <c:ptCount val="1"/>
                  <c:pt idx="0">
                    <c:v>0.0073249741714558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HSV'!$Y$43</c:f>
              <c:numCache>
                <c:formatCode>General</c:formatCode>
                <c:ptCount val="1"/>
                <c:pt idx="0">
                  <c:v>-0.01318655175245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357-4134-82AD-1BA579A1975E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HSV'!$P$97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357-4134-82AD-1BA579A197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98089320"/>
        <c:axId val="-1230522472"/>
      </c:barChart>
      <c:catAx>
        <c:axId val="1998089320"/>
        <c:scaling>
          <c:orientation val="minMax"/>
        </c:scaling>
        <c:delete val="0"/>
        <c:axPos val="t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230522472"/>
        <c:crosses val="autoZero"/>
        <c:auto val="1"/>
        <c:lblAlgn val="ctr"/>
        <c:lblOffset val="100"/>
        <c:noMultiLvlLbl val="0"/>
      </c:catAx>
      <c:valAx>
        <c:axId val="-1230522472"/>
        <c:scaling>
          <c:orientation val="maxMin"/>
          <c:max val="0.02"/>
          <c:min val="-0.0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8089320"/>
        <c:crosses val="autoZero"/>
        <c:crossBetween val="between"/>
        <c:majorUnit val="0.0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831-4639-B0EE-F626FB0CCB2D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49,'LMAN_Average, AAV'!$D$49:$K$49)</c:f>
                <c:numCache>
                  <c:formatCode>General</c:formatCode>
                  <c:ptCount val="9"/>
                  <c:pt idx="0">
                    <c:v>0.0305522601019506</c:v>
                  </c:pt>
                  <c:pt idx="1">
                    <c:v>0.00675234815654153</c:v>
                  </c:pt>
                  <c:pt idx="2">
                    <c:v>0.0384953316656576</c:v>
                  </c:pt>
                  <c:pt idx="3">
                    <c:v>0.0798327606513599</c:v>
                  </c:pt>
                  <c:pt idx="4">
                    <c:v>0.0617802267969258</c:v>
                  </c:pt>
                  <c:pt idx="5">
                    <c:v>0.0645268006994709</c:v>
                  </c:pt>
                  <c:pt idx="6">
                    <c:v>0.0374669833796966</c:v>
                  </c:pt>
                  <c:pt idx="7">
                    <c:v>0.0201511347901845</c:v>
                  </c:pt>
                  <c:pt idx="8">
                    <c:v>0.0770170438990019</c:v>
                  </c:pt>
                </c:numCache>
              </c:numRef>
            </c:plus>
            <c:minus>
              <c:numRef>
                <c:f>('LMAN_Average, AAV'!$B$49,'LMAN_Average, AAV'!$D$49:$K$49)</c:f>
                <c:numCache>
                  <c:formatCode>General</c:formatCode>
                  <c:ptCount val="9"/>
                  <c:pt idx="0">
                    <c:v>0.0305522601019506</c:v>
                  </c:pt>
                  <c:pt idx="1">
                    <c:v>0.00675234815654153</c:v>
                  </c:pt>
                  <c:pt idx="2">
                    <c:v>0.0384953316656576</c:v>
                  </c:pt>
                  <c:pt idx="3">
                    <c:v>0.0798327606513599</c:v>
                  </c:pt>
                  <c:pt idx="4">
                    <c:v>0.0617802267969258</c:v>
                  </c:pt>
                  <c:pt idx="5">
                    <c:v>0.0645268006994709</c:v>
                  </c:pt>
                  <c:pt idx="6">
                    <c:v>0.0374669833796966</c:v>
                  </c:pt>
                  <c:pt idx="7">
                    <c:v>0.0201511347901845</c:v>
                  </c:pt>
                  <c:pt idx="8">
                    <c:v>0.077017043899001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6">
                    <a:lumMod val="50000"/>
                  </a:schemeClr>
                </a:solidFill>
                <a:round/>
              </a:ln>
              <a:effectLst/>
            </c:spPr>
          </c:errBars>
          <c:val>
            <c:numRef>
              <c:f>('LMAN_Average, AAV'!$B$47,'LMAN_Average, AAV'!$D$47:$K$47)</c:f>
              <c:numCache>
                <c:formatCode>General</c:formatCode>
                <c:ptCount val="9"/>
                <c:pt idx="0">
                  <c:v>0.0177493141464636</c:v>
                </c:pt>
                <c:pt idx="1">
                  <c:v>-0.0825800611435265</c:v>
                </c:pt>
                <c:pt idx="2">
                  <c:v>-0.102292622073784</c:v>
                </c:pt>
                <c:pt idx="3">
                  <c:v>-0.132869407067933</c:v>
                </c:pt>
                <c:pt idx="4">
                  <c:v>-0.0822375287473568</c:v>
                </c:pt>
                <c:pt idx="5">
                  <c:v>-0.0695545616155429</c:v>
                </c:pt>
                <c:pt idx="6">
                  <c:v>-0.0355632764217614</c:v>
                </c:pt>
                <c:pt idx="7">
                  <c:v>0.018316551992765</c:v>
                </c:pt>
                <c:pt idx="8">
                  <c:v>-0.0989845600680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831-4639-B0EE-F626FB0CCB2D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53,'LMAN_Average, AAV'!$D$53:$K$53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plus>
            <c:minus>
              <c:numRef>
                <c:f>('LMAN_Average, AAV'!$B$53,'LMAN_Average, AAV'!$D$53:$K$53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LMAN_Average, AAV'!$B$51,'LMAN_Average, AAV'!$D$51:$K$51)</c:f>
              <c:numCache>
                <c:formatCode>General</c:formatCode>
                <c:ptCount val="9"/>
                <c:pt idx="0">
                  <c:v>-0.00717018180753137</c:v>
                </c:pt>
                <c:pt idx="1">
                  <c:v>0.0574937540080207</c:v>
                </c:pt>
                <c:pt idx="2">
                  <c:v>0.00740049973922074</c:v>
                </c:pt>
                <c:pt idx="3">
                  <c:v>0.0169369994483522</c:v>
                </c:pt>
                <c:pt idx="4">
                  <c:v>-0.00765234754301151</c:v>
                </c:pt>
                <c:pt idx="5">
                  <c:v>0.0222960600269891</c:v>
                </c:pt>
                <c:pt idx="6">
                  <c:v>-0.0053356289719826</c:v>
                </c:pt>
                <c:pt idx="7">
                  <c:v>-0.00182609799951625</c:v>
                </c:pt>
                <c:pt idx="8">
                  <c:v>0.0386037080556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831-4639-B0EE-F626FB0CCB2D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45,'LMAN_Average, AAV'!$D$45:$K$45)</c:f>
                <c:numCache>
                  <c:formatCode>General</c:formatCode>
                  <c:ptCount val="9"/>
                  <c:pt idx="0">
                    <c:v>0.0846216938068443</c:v>
                  </c:pt>
                  <c:pt idx="1">
                    <c:v>0.125130684218329</c:v>
                  </c:pt>
                  <c:pt idx="2">
                    <c:v>0.10445334786337</c:v>
                  </c:pt>
                  <c:pt idx="3">
                    <c:v>0.0247032805018539</c:v>
                  </c:pt>
                  <c:pt idx="4">
                    <c:v>0.0648425189657461</c:v>
                  </c:pt>
                  <c:pt idx="5">
                    <c:v>0.0727730606304692</c:v>
                  </c:pt>
                  <c:pt idx="6">
                    <c:v>0.128008422332233</c:v>
                  </c:pt>
                  <c:pt idx="7">
                    <c:v>0.0405922876029931</c:v>
                  </c:pt>
                  <c:pt idx="8">
                    <c:v>0.0851085795156925</c:v>
                  </c:pt>
                </c:numCache>
              </c:numRef>
            </c:plus>
            <c:minus>
              <c:numRef>
                <c:f>('LMAN_Average, AAV'!$B$45,'LMAN_Average, AAV'!$D$45:$K$45)</c:f>
                <c:numCache>
                  <c:formatCode>General</c:formatCode>
                  <c:ptCount val="9"/>
                  <c:pt idx="0">
                    <c:v>0.0846216938068443</c:v>
                  </c:pt>
                  <c:pt idx="1">
                    <c:v>0.125130684218329</c:v>
                  </c:pt>
                  <c:pt idx="2">
                    <c:v>0.10445334786337</c:v>
                  </c:pt>
                  <c:pt idx="3">
                    <c:v>0.0247032805018539</c:v>
                  </c:pt>
                  <c:pt idx="4">
                    <c:v>0.0648425189657461</c:v>
                  </c:pt>
                  <c:pt idx="5">
                    <c:v>0.0727730606304692</c:v>
                  </c:pt>
                  <c:pt idx="6">
                    <c:v>0.128008422332233</c:v>
                  </c:pt>
                  <c:pt idx="7">
                    <c:v>0.0405922876029931</c:v>
                  </c:pt>
                  <c:pt idx="8">
                    <c:v>0.0851085795156925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('LMAN_Average, AAV'!$B$43,'LMAN_Average, AAV'!$D$43:$K$43)</c:f>
              <c:numCache>
                <c:formatCode>General</c:formatCode>
                <c:ptCount val="9"/>
                <c:pt idx="0">
                  <c:v>-0.00457996745298862</c:v>
                </c:pt>
                <c:pt idx="1">
                  <c:v>-0.0364098819240132</c:v>
                </c:pt>
                <c:pt idx="2">
                  <c:v>0.241364510714318</c:v>
                </c:pt>
                <c:pt idx="3">
                  <c:v>0.0633174235096386</c:v>
                </c:pt>
                <c:pt idx="4">
                  <c:v>0.00118857096982931</c:v>
                </c:pt>
                <c:pt idx="5">
                  <c:v>0.095754815971593</c:v>
                </c:pt>
                <c:pt idx="6">
                  <c:v>-0.00159615180381549</c:v>
                </c:pt>
                <c:pt idx="7">
                  <c:v>0.073003181685722</c:v>
                </c:pt>
                <c:pt idx="8">
                  <c:v>0.125844792048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831-4639-B0EE-F626FB0CCB2D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1831-4639-B0EE-F626FB0CC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028735016"/>
        <c:axId val="-1984901256"/>
      </c:barChart>
      <c:catAx>
        <c:axId val="-10287350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984901256"/>
        <c:crosses val="autoZero"/>
        <c:auto val="1"/>
        <c:lblAlgn val="ctr"/>
        <c:lblOffset val="100"/>
        <c:noMultiLvlLbl val="0"/>
      </c:catAx>
      <c:valAx>
        <c:axId val="-1984901256"/>
        <c:scaling>
          <c:orientation val="minMax"/>
          <c:max val="0.36"/>
          <c:min val="-0.3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028735016"/>
        <c:crosses val="autoZero"/>
        <c:crossBetween val="between"/>
        <c:majorUnit val="0.18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Y$49</c:f>
                <c:numCache>
                  <c:formatCode>General</c:formatCode>
                  <c:ptCount val="1"/>
                  <c:pt idx="0">
                    <c:v>0.00268390949461808</c:v>
                  </c:pt>
                </c:numCache>
              </c:numRef>
            </c:plus>
            <c:minus>
              <c:numRef>
                <c:f>'LMAN_Average, AAV'!$Y$49</c:f>
                <c:numCache>
                  <c:formatCode>General</c:formatCode>
                  <c:ptCount val="1"/>
                  <c:pt idx="0">
                    <c:v>0.0026839094946180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AAV'!$Y$47</c:f>
              <c:numCache>
                <c:formatCode>General</c:formatCode>
                <c:ptCount val="1"/>
                <c:pt idx="0">
                  <c:v>0.005912592517629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357-4134-82AD-1BA579A1975E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Y$53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plus>
            <c:minus>
              <c:numRef>
                <c:f>'LMAN_Average, AAV'!$Y$53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AAV'!$Y$51</c:f>
              <c:numCache>
                <c:formatCode>General</c:formatCode>
                <c:ptCount val="1"/>
                <c:pt idx="0">
                  <c:v>0.0001128853422126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357-4134-82AD-1BA579A1975E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Y$45</c:f>
                <c:numCache>
                  <c:formatCode>General</c:formatCode>
                  <c:ptCount val="1"/>
                  <c:pt idx="0">
                    <c:v>0.00199945977716053</c:v>
                  </c:pt>
                </c:numCache>
              </c:numRef>
            </c:plus>
            <c:minus>
              <c:numRef>
                <c:f>'LMAN_Average, AAV'!$Y$45</c:f>
                <c:numCache>
                  <c:formatCode>General</c:formatCode>
                  <c:ptCount val="1"/>
                  <c:pt idx="0">
                    <c:v>0.00199945977716053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AAV'!$Y$43</c:f>
              <c:numCache>
                <c:formatCode>General</c:formatCode>
                <c:ptCount val="1"/>
                <c:pt idx="0">
                  <c:v>-0.005450658531577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357-4134-82AD-1BA579A1975E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AAV'!$P$97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357-4134-82AD-1BA579A197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029633816"/>
        <c:axId val="1823141192"/>
      </c:barChart>
      <c:catAx>
        <c:axId val="-1029633816"/>
        <c:scaling>
          <c:orientation val="minMax"/>
        </c:scaling>
        <c:delete val="0"/>
        <c:axPos val="t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3141192"/>
        <c:crosses val="autoZero"/>
        <c:auto val="1"/>
        <c:lblAlgn val="ctr"/>
        <c:lblOffset val="100"/>
        <c:noMultiLvlLbl val="0"/>
      </c:catAx>
      <c:valAx>
        <c:axId val="1823141192"/>
        <c:scaling>
          <c:orientation val="maxMin"/>
          <c:max val="0.008"/>
          <c:min val="-0.00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029633816"/>
        <c:crosses val="autoZero"/>
        <c:crossBetween val="between"/>
        <c:majorUnit val="0.00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336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9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4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2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5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3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73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39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05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33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4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4A73-A334-4919-8CF7-7DD6E172AE85}" type="datetimeFigureOut">
              <a:rPr lang="en-US" smtClean="0"/>
              <a:t>5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8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5473" y="-3245830"/>
            <a:ext cx="10515600" cy="1325563"/>
          </a:xfrm>
        </p:spPr>
        <p:txBody>
          <a:bodyPr>
            <a:normAutofit/>
          </a:bodyPr>
          <a:lstStyle/>
          <a:p>
            <a:r>
              <a:rPr lang="en-US" sz="2000" dirty="0" smtClean="0"/>
              <a:t>LMAN – separated by virus; </a:t>
            </a:r>
            <a:r>
              <a:rPr lang="en-US" sz="2000" dirty="0" err="1" smtClean="0"/>
              <a:t>Intersyllable</a:t>
            </a:r>
            <a:r>
              <a:rPr lang="en-US" sz="2000" dirty="0" smtClean="0"/>
              <a:t> variability</a:t>
            </a:r>
            <a:endParaRPr lang="en-US" sz="2000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5604265"/>
              </p:ext>
            </p:extLst>
          </p:nvPr>
        </p:nvGraphicFramePr>
        <p:xfrm>
          <a:off x="848974" y="900077"/>
          <a:ext cx="73152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4995829"/>
              </p:ext>
            </p:extLst>
          </p:nvPr>
        </p:nvGraphicFramePr>
        <p:xfrm>
          <a:off x="9127049" y="923473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0134688"/>
              </p:ext>
            </p:extLst>
          </p:nvPr>
        </p:nvGraphicFramePr>
        <p:xfrm>
          <a:off x="802163" y="4460921"/>
          <a:ext cx="73152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8512116"/>
              </p:ext>
            </p:extLst>
          </p:nvPr>
        </p:nvGraphicFramePr>
        <p:xfrm>
          <a:off x="9033462" y="4440942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23569" y="646474"/>
            <a:ext cx="7037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plitude    Duration           FF               Pitch             FM              AM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          Entropy    Goodness     Mean Freq</a:t>
            </a:r>
            <a:r>
              <a:rPr lang="en-US" sz="1200" dirty="0"/>
              <a:t>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17205" y="4355247"/>
            <a:ext cx="7037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plitude    Duration           FF               Pitch             FM              AM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          Entropy    Goodness     Mean Freq</a:t>
            </a:r>
            <a:r>
              <a:rPr lang="en-US" sz="1200" dirty="0"/>
              <a:t>.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673852" y="536201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659931" y="1814248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7647061" y="1933510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7537475" y="5362012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45136" y="345190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/>
              <a:t>HSV only </a:t>
            </a:r>
            <a:endParaRPr lang="en-US" b="1" u="sng" dirty="0"/>
          </a:p>
        </p:txBody>
      </p:sp>
      <p:sp>
        <p:nvSpPr>
          <p:cNvPr id="20" name="TextBox 19"/>
          <p:cNvSpPr txBox="1"/>
          <p:nvPr/>
        </p:nvSpPr>
        <p:spPr>
          <a:xfrm>
            <a:off x="545136" y="3878834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err="1" smtClean="0"/>
              <a:t>CaMKII</a:t>
            </a:r>
            <a:r>
              <a:rPr lang="en-US" b="1" u="sng" dirty="0" smtClean="0"/>
              <a:t> AAV only </a:t>
            </a:r>
            <a:endParaRPr lang="en-US" b="1" u="sng" dirty="0"/>
          </a:p>
        </p:txBody>
      </p:sp>
      <p:sp>
        <p:nvSpPr>
          <p:cNvPr id="21" name="TextBox 20"/>
          <p:cNvSpPr txBox="1"/>
          <p:nvPr/>
        </p:nvSpPr>
        <p:spPr>
          <a:xfrm>
            <a:off x="9889783" y="646474"/>
            <a:ext cx="21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dentity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9745410" y="4260014"/>
            <a:ext cx="21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dentit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6826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440480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53216" y="366691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357588" y="366691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85568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88</TotalTime>
  <Words>93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LMAN – separated by virus; Intersyllable variability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e Lab</dc:creator>
  <cp:lastModifiedBy>Jon Heston</cp:lastModifiedBy>
  <cp:revision>63</cp:revision>
  <dcterms:created xsi:type="dcterms:W3CDTF">2016-02-17T18:00:22Z</dcterms:created>
  <dcterms:modified xsi:type="dcterms:W3CDTF">2016-05-02T03:37:58Z</dcterms:modified>
</cp:coreProperties>
</file>